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1" r:id="rId2"/>
    <p:sldId id="291" r:id="rId3"/>
  </p:sldIdLst>
  <p:sldSz cx="6858000" cy="9144000" type="screen4x3"/>
  <p:notesSz cx="6799263" cy="99298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55" userDrawn="1">
          <p15:clr>
            <a:srgbClr val="A4A3A4"/>
          </p15:clr>
        </p15:guide>
        <p15:guide id="2" pos="415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9933"/>
    <a:srgbClr val="CC6600"/>
    <a:srgbClr val="0219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634" autoAdjust="0"/>
    <p:restoredTop sz="90769" autoAdjust="0"/>
  </p:normalViewPr>
  <p:slideViewPr>
    <p:cSldViewPr snapToObjects="1">
      <p:cViewPr varScale="1">
        <p:scale>
          <a:sx n="63" d="100"/>
          <a:sy n="63" d="100"/>
        </p:scale>
        <p:origin x="2722" y="62"/>
      </p:cViewPr>
      <p:guideLst>
        <p:guide orient="horz" pos="3855"/>
        <p:guide pos="415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7088" cy="497047"/>
          </a:xfrm>
          <a:prstGeom prst="rect">
            <a:avLst/>
          </a:prstGeom>
        </p:spPr>
        <p:txBody>
          <a:bodyPr vert="horz" lIns="91458" tIns="45729" rIns="91458" bIns="4572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587" y="0"/>
            <a:ext cx="2947088" cy="497047"/>
          </a:xfrm>
          <a:prstGeom prst="rect">
            <a:avLst/>
          </a:prstGeom>
        </p:spPr>
        <p:txBody>
          <a:bodyPr vert="horz" lIns="91458" tIns="45729" rIns="91458" bIns="45729" rtlCol="0"/>
          <a:lstStyle>
            <a:lvl1pPr algn="r">
              <a:defRPr sz="1200"/>
            </a:lvl1pPr>
          </a:lstStyle>
          <a:p>
            <a:fld id="{B41635DB-203D-4F27-9EF8-14B11657C4C9}" type="datetimeFigureOut">
              <a:rPr lang="en-US" smtClean="0"/>
              <a:t>2/6/2026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2413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58" tIns="45729" rIns="91458" bIns="45729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609" y="4716383"/>
            <a:ext cx="5440046" cy="4468654"/>
          </a:xfrm>
          <a:prstGeom prst="rect">
            <a:avLst/>
          </a:prstGeom>
        </p:spPr>
        <p:txBody>
          <a:bodyPr vert="horz" lIns="91458" tIns="45729" rIns="91458" bIns="45729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1179"/>
            <a:ext cx="2947088" cy="497046"/>
          </a:xfrm>
          <a:prstGeom prst="rect">
            <a:avLst/>
          </a:prstGeom>
        </p:spPr>
        <p:txBody>
          <a:bodyPr vert="horz" lIns="91458" tIns="45729" rIns="91458" bIns="4572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587" y="9431179"/>
            <a:ext cx="2947088" cy="497046"/>
          </a:xfrm>
          <a:prstGeom prst="rect">
            <a:avLst/>
          </a:prstGeom>
        </p:spPr>
        <p:txBody>
          <a:bodyPr vert="horz" lIns="91458" tIns="45729" rIns="91458" bIns="45729" rtlCol="0" anchor="b"/>
          <a:lstStyle>
            <a:lvl1pPr algn="r">
              <a:defRPr sz="1200"/>
            </a:lvl1pPr>
          </a:lstStyle>
          <a:p>
            <a:fld id="{AEEEC841-A46D-4E46-B07A-ADB5C9032878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472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E363-5A63-42FD-B43D-CE49E0913A0F}" type="datetimeFigureOut">
              <a:rPr lang="fr-FR" smtClean="0"/>
              <a:t>06/02/202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F99B5-CE25-4980-919E-4968A6BD957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64649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E363-5A63-42FD-B43D-CE49E0913A0F}" type="datetimeFigureOut">
              <a:rPr lang="fr-FR" smtClean="0"/>
              <a:t>06/02/202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F99B5-CE25-4980-919E-4968A6BD957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18981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E363-5A63-42FD-B43D-CE49E0913A0F}" type="datetimeFigureOut">
              <a:rPr lang="fr-FR" smtClean="0"/>
              <a:t>06/02/202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F99B5-CE25-4980-919E-4968A6BD957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6591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E363-5A63-42FD-B43D-CE49E0913A0F}" type="datetimeFigureOut">
              <a:rPr lang="fr-FR" smtClean="0"/>
              <a:t>06/02/202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F99B5-CE25-4980-919E-4968A6BD957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98037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E363-5A63-42FD-B43D-CE49E0913A0F}" type="datetimeFigureOut">
              <a:rPr lang="fr-FR" smtClean="0"/>
              <a:t>06/02/202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F99B5-CE25-4980-919E-4968A6BD957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74602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E363-5A63-42FD-B43D-CE49E0913A0F}" type="datetimeFigureOut">
              <a:rPr lang="fr-FR" smtClean="0"/>
              <a:t>06/02/202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F99B5-CE25-4980-919E-4968A6BD957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5515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E363-5A63-42FD-B43D-CE49E0913A0F}" type="datetimeFigureOut">
              <a:rPr lang="fr-FR" smtClean="0"/>
              <a:t>06/02/202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F99B5-CE25-4980-919E-4968A6BD957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548130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E363-5A63-42FD-B43D-CE49E0913A0F}" type="datetimeFigureOut">
              <a:rPr lang="fr-FR" smtClean="0"/>
              <a:t>06/02/202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F99B5-CE25-4980-919E-4968A6BD957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8203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E363-5A63-42FD-B43D-CE49E0913A0F}" type="datetimeFigureOut">
              <a:rPr lang="fr-FR" smtClean="0"/>
              <a:t>06/02/202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F99B5-CE25-4980-919E-4968A6BD957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67998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E363-5A63-42FD-B43D-CE49E0913A0F}" type="datetimeFigureOut">
              <a:rPr lang="fr-FR" smtClean="0"/>
              <a:t>06/02/202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F99B5-CE25-4980-919E-4968A6BD957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45206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41E363-5A63-42FD-B43D-CE49E0913A0F}" type="datetimeFigureOut">
              <a:rPr lang="fr-FR" smtClean="0"/>
              <a:t>06/02/202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6F99B5-CE25-4980-919E-4968A6BD957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07770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41E363-5A63-42FD-B43D-CE49E0913A0F}" type="datetimeFigureOut">
              <a:rPr lang="fr-FR" smtClean="0"/>
              <a:t>06/02/202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6F99B5-CE25-4980-919E-4968A6BD957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2641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3.w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7" Type="http://schemas.openxmlformats.org/officeDocument/2006/relationships/image" Target="../media/image6.emf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6.bin"/><Relationship Id="rId5" Type="http://schemas.openxmlformats.org/officeDocument/2006/relationships/image" Target="../media/image5.emf"/><Relationship Id="rId4" Type="http://schemas.openxmlformats.org/officeDocument/2006/relationships/oleObject" Target="../embeddings/oleObject5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Rectangle 65"/>
          <p:cNvSpPr/>
          <p:nvPr/>
        </p:nvSpPr>
        <p:spPr>
          <a:xfrm>
            <a:off x="45195" y="4335540"/>
            <a:ext cx="6552455" cy="215276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1. Presence of maternally derived IAV-specific IgG in some piglets on the day of vaccination.</a:t>
            </a:r>
            <a:endParaRPr lang="fr-FR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a) Serum levels of IAV-specific IgG in piglets with (MDA</a:t>
            </a:r>
            <a:r>
              <a:rPr lang="en-US" sz="120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or without (MDA</a:t>
            </a:r>
            <a:r>
              <a:rPr lang="en-US" sz="120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-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maternally derived IAV-specific IgG at 0 day post-vaccination (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dpv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, prior to the first vaccination. The dotted line indicates a threshold of positivity (1.5 µg/mL).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b) Corresponding serum levels of IAV-specific IgG in the sows of the same litters. The dotted line indicates a threshold of positivity (1.5 µg/mL). </a:t>
            </a:r>
            <a:endParaRPr lang="fr-FR" sz="12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(c) Serum IAV-specific IgG levels in vaccinated (V) and non-vaccinated (NV) piglets with maternally derived antibodies (MDA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+</a:t>
            </a:r>
            <a:r>
              <a:rPr lang="en-US" sz="1200" dirty="0"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). The dotted line indicates a threshold of positivity (1.5 µg/mL).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Obje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8955562"/>
              </p:ext>
            </p:extLst>
          </p:nvPr>
        </p:nvGraphicFramePr>
        <p:xfrm>
          <a:off x="80963" y="295275"/>
          <a:ext cx="1717675" cy="14557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2" imgW="2862000" imgH="2426400" progId="Prism5.Document">
                  <p:embed/>
                </p:oleObj>
              </mc:Choice>
              <mc:Fallback>
                <p:oleObj name="Prism 5" r:id="rId2" imgW="2862000" imgH="24264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0963" y="295275"/>
                        <a:ext cx="1717675" cy="14557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2444592"/>
              </p:ext>
            </p:extLst>
          </p:nvPr>
        </p:nvGraphicFramePr>
        <p:xfrm>
          <a:off x="1655763" y="290513"/>
          <a:ext cx="1860550" cy="1455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4" imgW="3099960" imgH="2426400" progId="Prism5.Document">
                  <p:embed/>
                </p:oleObj>
              </mc:Choice>
              <mc:Fallback>
                <p:oleObj name="Prism 5" r:id="rId4" imgW="3099960" imgH="24264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655763" y="290513"/>
                        <a:ext cx="1860550" cy="14557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ZoneTexte 10"/>
          <p:cNvSpPr txBox="1"/>
          <p:nvPr/>
        </p:nvSpPr>
        <p:spPr>
          <a:xfrm>
            <a:off x="17823" y="70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1719214" y="-50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" name="Objet 2">
            <a:extLst>
              <a:ext uri="{FF2B5EF4-FFF2-40B4-BE49-F238E27FC236}">
                <a16:creationId xmlns:a16="http://schemas.microsoft.com/office/drawing/2014/main" id="{35A49BB7-A9E8-43AE-39FB-56262C4C0E6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5500706"/>
              </p:ext>
            </p:extLst>
          </p:nvPr>
        </p:nvGraphicFramePr>
        <p:xfrm>
          <a:off x="152400" y="1865313"/>
          <a:ext cx="3254375" cy="2465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6" imgW="5426640" imgH="4106880" progId="Prism5.Document">
                  <p:embed/>
                </p:oleObj>
              </mc:Choice>
              <mc:Fallback>
                <p:oleObj name="Prism 5" r:id="rId6" imgW="5426640" imgH="4106880" progId="Prism5.Document">
                  <p:embed/>
                  <p:pic>
                    <p:nvPicPr>
                      <p:cNvPr id="13" name="Objet 12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52400" y="1865313"/>
                        <a:ext cx="3254375" cy="2465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ZoneTexte 3">
            <a:extLst>
              <a:ext uri="{FF2B5EF4-FFF2-40B4-BE49-F238E27FC236}">
                <a16:creationId xmlns:a16="http://schemas.microsoft.com/office/drawing/2014/main" id="{CF23FB62-80B8-90A3-5BE7-DECB8310BE0E}"/>
              </a:ext>
            </a:extLst>
          </p:cNvPr>
          <p:cNvSpPr txBox="1"/>
          <p:nvPr/>
        </p:nvSpPr>
        <p:spPr>
          <a:xfrm>
            <a:off x="20565" y="186248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76506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Rectangle 65"/>
          <p:cNvSpPr/>
          <p:nvPr/>
        </p:nvSpPr>
        <p:spPr>
          <a:xfrm>
            <a:off x="45195" y="4335540"/>
            <a:ext cx="6552455" cy="25605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upplementary Figure 2. Hemagglutination inhibition (HAI) titers in pig sera after vaccination in animals with or without maternally derived IAV-specific IgG.</a:t>
            </a:r>
            <a:endParaRPr lang="fr-FR" sz="1200" kern="1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a) HAI titers in the sera of piglets from litters with (MDA⁺) or without (MDA⁻) maternally derived IAV-specific IgG at 0 day post-vaccination (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dpv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, prior to the first vaccination. The dotted line indicates the 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eroprotection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threshold (HAI ≥40).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b) HAI titers in the corresponding sows’ sera. The dotted line indicates the 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eroprotection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threshold (HAI ≥ 40).</a:t>
            </a: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c) Comparison of HAI titers in piglet sera after vaccination between MDA⁺ and MDA⁻ piglets. The dotted line indicates the </a:t>
            </a:r>
            <a:r>
              <a:rPr lang="en-US" sz="12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seroprotection</a:t>
            </a:r>
            <a:r>
              <a:rPr lang="en-US" sz="12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threshold (HAI ≥40). No significant differences were observed between the two groups at any time point. Statistical analyses were performed using one-way ANOVA followed by Tukey’s post hoc test.</a:t>
            </a:r>
            <a:endParaRPr lang="fr-FR" sz="1200" kern="1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17823" y="70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1719214" y="-508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CF23FB62-80B8-90A3-5BE7-DECB8310BE0E}"/>
              </a:ext>
            </a:extLst>
          </p:cNvPr>
          <p:cNvSpPr txBox="1"/>
          <p:nvPr/>
        </p:nvSpPr>
        <p:spPr>
          <a:xfrm>
            <a:off x="20565" y="1862481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Objet 4">
            <a:extLst>
              <a:ext uri="{FF2B5EF4-FFF2-40B4-BE49-F238E27FC236}">
                <a16:creationId xmlns:a16="http://schemas.microsoft.com/office/drawing/2014/main" id="{F79671B6-717E-152F-DEA9-228C2E7E574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45920016"/>
              </p:ext>
            </p:extLst>
          </p:nvPr>
        </p:nvGraphicFramePr>
        <p:xfrm>
          <a:off x="-15875" y="287338"/>
          <a:ext cx="1684338" cy="1454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2" imgW="2807280" imgH="2426400" progId="Prism5.Document">
                  <p:embed/>
                </p:oleObj>
              </mc:Choice>
              <mc:Fallback>
                <p:oleObj name="Prism 5" r:id="rId2" imgW="2807280" imgH="2426400" progId="Prism5.Document">
                  <p:embed/>
                  <p:pic>
                    <p:nvPicPr>
                      <p:cNvPr id="5" name="Objet 4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-15875" y="287338"/>
                        <a:ext cx="1684338" cy="1454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t 5">
            <a:extLst>
              <a:ext uri="{FF2B5EF4-FFF2-40B4-BE49-F238E27FC236}">
                <a16:creationId xmlns:a16="http://schemas.microsoft.com/office/drawing/2014/main" id="{B8DA7B97-3CE3-4B2B-11D0-62B3E6091EC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4405361"/>
              </p:ext>
            </p:extLst>
          </p:nvPr>
        </p:nvGraphicFramePr>
        <p:xfrm>
          <a:off x="1604963" y="312738"/>
          <a:ext cx="1760537" cy="1454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4" imgW="2935080" imgH="2426400" progId="Prism5.Document">
                  <p:embed/>
                </p:oleObj>
              </mc:Choice>
              <mc:Fallback>
                <p:oleObj name="Prism 5" r:id="rId4" imgW="2935080" imgH="2426400" progId="Prism5.Document">
                  <p:embed/>
                  <p:pic>
                    <p:nvPicPr>
                      <p:cNvPr id="8" name="Objet 7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604963" y="312738"/>
                        <a:ext cx="1760537" cy="14541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t 7">
            <a:extLst>
              <a:ext uri="{FF2B5EF4-FFF2-40B4-BE49-F238E27FC236}">
                <a16:creationId xmlns:a16="http://schemas.microsoft.com/office/drawing/2014/main" id="{C7E20F1C-E189-8A9F-F506-CCF6B6317FF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17307308"/>
              </p:ext>
            </p:extLst>
          </p:nvPr>
        </p:nvGraphicFramePr>
        <p:xfrm>
          <a:off x="-31467" y="1897728"/>
          <a:ext cx="3492500" cy="2463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5" r:id="rId6" imgW="5820120" imgH="4106880" progId="Prism5.Document">
                  <p:embed/>
                </p:oleObj>
              </mc:Choice>
              <mc:Fallback>
                <p:oleObj name="Prism 5" r:id="rId6" imgW="5820120" imgH="4106880" progId="Prism5.Document">
                  <p:embed/>
                  <p:pic>
                    <p:nvPicPr>
                      <p:cNvPr id="3" name="Objet 2">
                        <a:extLst>
                          <a:ext uri="{FF2B5EF4-FFF2-40B4-BE49-F238E27FC236}">
                            <a16:creationId xmlns:a16="http://schemas.microsoft.com/office/drawing/2014/main" id="{C9F85E49-BEAC-5716-B8D8-7703350D015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-31467" y="1897728"/>
                        <a:ext cx="3492500" cy="2463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45441857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342</TotalTime>
  <Words>306</Words>
  <Application>Microsoft Office PowerPoint</Application>
  <PresentationFormat>Affichage à l'écran (4:3)</PresentationFormat>
  <Paragraphs>14</Paragraphs>
  <Slides>2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8" baseType="lpstr">
      <vt:lpstr>Aptos</vt:lpstr>
      <vt:lpstr>Arial</vt:lpstr>
      <vt:lpstr>Calibri</vt:lpstr>
      <vt:lpstr>Times New Roman</vt:lpstr>
      <vt:lpstr>Thème Office</vt:lpstr>
      <vt:lpstr>Prism 5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ny</dc:creator>
  <cp:lastModifiedBy>Fany Blanc</cp:lastModifiedBy>
  <cp:revision>494</cp:revision>
  <cp:lastPrinted>2019-07-23T12:01:02Z</cp:lastPrinted>
  <dcterms:created xsi:type="dcterms:W3CDTF">2016-03-14T09:39:44Z</dcterms:created>
  <dcterms:modified xsi:type="dcterms:W3CDTF">2026-02-06T17:36:01Z</dcterms:modified>
</cp:coreProperties>
</file>